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7" r:id="rId3"/>
    <p:sldId id="265" r:id="rId4"/>
    <p:sldId id="268" r:id="rId5"/>
    <p:sldId id="269" r:id="rId6"/>
    <p:sldId id="264" r:id="rId7"/>
    <p:sldId id="266" r:id="rId8"/>
    <p:sldId id="262" r:id="rId9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00"/>
    <a:srgbClr val="FFC0CB"/>
    <a:srgbClr val="DAA520"/>
    <a:srgbClr val="FFA500"/>
    <a:srgbClr val="FA8072"/>
    <a:srgbClr val="0000FF"/>
    <a:srgbClr val="D02090"/>
    <a:srgbClr val="00FF7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65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4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542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66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646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2756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541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876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343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2649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196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630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98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C59A3-07B7-4373-9237-CBFC2BDCB99C}" type="datetimeFigureOut">
              <a:rPr kumimoji="1" lang="ja-JP" altLang="en-US" smtClean="0"/>
              <a:t>2019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EB756-D02B-4489-9C2A-8706FC74A0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2649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3A5D5F5-0FE2-482C-BB79-0ECE78FBA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667" y="1045459"/>
            <a:ext cx="3483871" cy="270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2DF8A2B-CA8E-4250-BEF1-FB75057683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7049" y="1003577"/>
            <a:ext cx="2203200" cy="5483764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BEEEE0B-972D-4265-859E-F18E8F45C879}"/>
              </a:ext>
            </a:extLst>
          </p:cNvPr>
          <p:cNvSpPr txBox="1"/>
          <p:nvPr/>
        </p:nvSpPr>
        <p:spPr>
          <a:xfrm flipH="1">
            <a:off x="306297" y="602202"/>
            <a:ext cx="649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BI5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035B388-4BF7-453E-8C99-975B3B87BDD0}"/>
              </a:ext>
            </a:extLst>
          </p:cNvPr>
          <p:cNvSpPr txBox="1"/>
          <p:nvPr/>
        </p:nvSpPr>
        <p:spPr>
          <a:xfrm>
            <a:off x="428163" y="6818190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2721310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5B8BB2F4-D675-40BF-A384-14AA03667C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82855" y="725558"/>
            <a:ext cx="2202813" cy="54828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FFC125D-CBCB-4E38-8BF2-9EF15C95FECF}"/>
              </a:ext>
            </a:extLst>
          </p:cNvPr>
          <p:cNvSpPr txBox="1"/>
          <p:nvPr/>
        </p:nvSpPr>
        <p:spPr>
          <a:xfrm flipH="1">
            <a:off x="346054" y="448559"/>
            <a:ext cx="649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BA2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E0FF432-847F-42C0-8AF5-FB113C214A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054" y="766958"/>
            <a:ext cx="3483871" cy="27000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D8FBF62-D578-4EBE-9749-E28CB0652E45}"/>
              </a:ext>
            </a:extLst>
          </p:cNvPr>
          <p:cNvSpPr txBox="1"/>
          <p:nvPr/>
        </p:nvSpPr>
        <p:spPr>
          <a:xfrm>
            <a:off x="438102" y="6439043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420339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1B68D14-5D03-4AC5-8504-B5101562D2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8735" y="767666"/>
            <a:ext cx="3483871" cy="270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3C6DB45-B912-4CDC-87C6-A89E62AFFB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3267" y="767666"/>
            <a:ext cx="2204259" cy="54864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F40259-48DD-4C43-8C13-50C5DDC9FDAA}"/>
              </a:ext>
            </a:extLst>
          </p:cNvPr>
          <p:cNvSpPr txBox="1"/>
          <p:nvPr/>
        </p:nvSpPr>
        <p:spPr>
          <a:xfrm flipH="1">
            <a:off x="486134" y="467519"/>
            <a:ext cx="1215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NCED4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5EE554A-F5D8-4B34-ACCA-E1EEB067889A}"/>
              </a:ext>
            </a:extLst>
          </p:cNvPr>
          <p:cNvSpPr txBox="1"/>
          <p:nvPr/>
        </p:nvSpPr>
        <p:spPr>
          <a:xfrm>
            <a:off x="578735" y="6539894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34416261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611C196-2749-4517-B8A9-C7725BDD13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592" y="874229"/>
            <a:ext cx="3483871" cy="270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043662-659E-4E2F-B147-983C46DEDF56}"/>
              </a:ext>
            </a:extLst>
          </p:cNvPr>
          <p:cNvSpPr txBox="1"/>
          <p:nvPr/>
        </p:nvSpPr>
        <p:spPr>
          <a:xfrm flipH="1">
            <a:off x="486134" y="467519"/>
            <a:ext cx="1215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A 2ox7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FB65C26-CCD3-474A-AEC2-462576A598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7149" y="874229"/>
            <a:ext cx="2204259" cy="54864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8D5644E-DE11-480B-8D03-C5B5A1BC9C16}"/>
              </a:ext>
            </a:extLst>
          </p:cNvPr>
          <p:cNvSpPr txBox="1"/>
          <p:nvPr/>
        </p:nvSpPr>
        <p:spPr>
          <a:xfrm>
            <a:off x="487843" y="6788373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3518168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B7D8C22-4BF2-4E05-B296-86D72E53D9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4071" y="775252"/>
            <a:ext cx="2204259" cy="54864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32AD0BE-24D3-429A-B126-68391B8DAF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175" y="775252"/>
            <a:ext cx="3483871" cy="2700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1A21AFF-1442-476E-96EB-F6F9308E0A83}"/>
              </a:ext>
            </a:extLst>
          </p:cNvPr>
          <p:cNvSpPr txBox="1"/>
          <p:nvPr/>
        </p:nvSpPr>
        <p:spPr>
          <a:xfrm flipH="1">
            <a:off x="248480" y="448558"/>
            <a:ext cx="1215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A 20ox1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88AB983-C13F-4B8D-8395-D9C6C343E4B9}"/>
              </a:ext>
            </a:extLst>
          </p:cNvPr>
          <p:cNvSpPr txBox="1"/>
          <p:nvPr/>
        </p:nvSpPr>
        <p:spPr>
          <a:xfrm>
            <a:off x="428163" y="6818190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26319656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B8D616D-62C3-4D8A-885F-6C696E0D94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862" y="883413"/>
            <a:ext cx="3483871" cy="270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1FB3987-1E5C-4314-8630-B518CB8CFA74}"/>
              </a:ext>
            </a:extLst>
          </p:cNvPr>
          <p:cNvSpPr txBox="1"/>
          <p:nvPr/>
        </p:nvSpPr>
        <p:spPr>
          <a:xfrm flipH="1">
            <a:off x="439836" y="544330"/>
            <a:ext cx="1215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UGT73C5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27AC842-2FAD-4513-93B1-55A6A3A7A9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6969" y="883413"/>
            <a:ext cx="2204259" cy="54864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2683B5D-B1E4-4F82-B047-A780204491DC}"/>
              </a:ext>
            </a:extLst>
          </p:cNvPr>
          <p:cNvSpPr txBox="1"/>
          <p:nvPr/>
        </p:nvSpPr>
        <p:spPr>
          <a:xfrm>
            <a:off x="428163" y="6818190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14898893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5C54D9D-72D6-4AD9-B2BB-D9F95583F438}"/>
              </a:ext>
            </a:extLst>
          </p:cNvPr>
          <p:cNvSpPr txBox="1"/>
          <p:nvPr/>
        </p:nvSpPr>
        <p:spPr>
          <a:xfrm flipH="1">
            <a:off x="306296" y="602202"/>
            <a:ext cx="7671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NAC016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914AD308-A2D3-4188-BFFF-F0DF8CA620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627" y="973621"/>
            <a:ext cx="3483871" cy="270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A35A1CE-5F4A-4524-B45A-58D4CFF3BD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3340" y="973621"/>
            <a:ext cx="2204259" cy="54864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172A9D3-4CE6-4821-9D8D-7E51A446C2CC}"/>
              </a:ext>
            </a:extLst>
          </p:cNvPr>
          <p:cNvSpPr txBox="1"/>
          <p:nvPr/>
        </p:nvSpPr>
        <p:spPr>
          <a:xfrm>
            <a:off x="517615" y="6748616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29704896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0F1467A-78D0-4F2A-B1F6-7B544FCD4B1B}"/>
              </a:ext>
            </a:extLst>
          </p:cNvPr>
          <p:cNvSpPr txBox="1"/>
          <p:nvPr/>
        </p:nvSpPr>
        <p:spPr>
          <a:xfrm flipH="1">
            <a:off x="306297" y="602202"/>
            <a:ext cx="649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PT7</a:t>
            </a:r>
            <a:endParaRPr kumimoji="1" lang="ja-JP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2C4302A-DA28-4CA8-88E6-42FB9D2F53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047" y="935533"/>
            <a:ext cx="3482473" cy="2698917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3E5B8B4-2357-4B79-9AA1-1B958739E3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0349" y="935533"/>
            <a:ext cx="2204259" cy="54864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20AA30-2B7A-46DC-8A93-3D52B43C05C1}"/>
              </a:ext>
            </a:extLst>
          </p:cNvPr>
          <p:cNvSpPr txBox="1"/>
          <p:nvPr/>
        </p:nvSpPr>
        <p:spPr>
          <a:xfrm>
            <a:off x="517615" y="6748616"/>
            <a:ext cx="2427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. Ueda et al</a:t>
            </a:r>
          </a:p>
        </p:txBody>
      </p:sp>
    </p:spTree>
    <p:extLst>
      <p:ext uri="{BB962C8B-B14F-4D97-AF65-F5344CB8AC3E}">
        <p14:creationId xmlns:p14="http://schemas.microsoft.com/office/powerpoint/2010/main" val="2216691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8</Words>
  <Application>Microsoft Office PowerPoint</Application>
  <PresentationFormat>A4 210 x 297 mm</PresentationFormat>
  <Paragraphs>16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実 上田</dc:creator>
  <cp:lastModifiedBy>上田 実</cp:lastModifiedBy>
  <cp:revision>176</cp:revision>
  <cp:lastPrinted>2019-08-06T03:58:13Z</cp:lastPrinted>
  <dcterms:created xsi:type="dcterms:W3CDTF">2018-10-01T05:50:51Z</dcterms:created>
  <dcterms:modified xsi:type="dcterms:W3CDTF">2019-08-15T12:04:21Z</dcterms:modified>
</cp:coreProperties>
</file>